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7578725" cy="10691813"/>
  <p:notesSz cx="6858000" cy="9144000"/>
  <p:defaultTextStyle>
    <a:defPPr>
      <a:defRPr lang="fr-FR"/>
    </a:defPPr>
    <a:lvl1pPr marL="0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1pPr>
    <a:lvl2pPr marL="498257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2pPr>
    <a:lvl3pPr marL="996513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3pPr>
    <a:lvl4pPr marL="1494770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4pPr>
    <a:lvl5pPr marL="1993026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5pPr>
    <a:lvl6pPr marL="2491283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6pPr>
    <a:lvl7pPr marL="2989539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7pPr>
    <a:lvl8pPr marL="3487796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8pPr>
    <a:lvl9pPr marL="3986052" algn="l" defTabSz="996513" rtl="0" eaLnBrk="1" latinLnBrk="0" hangingPunct="1">
      <a:defRPr sz="196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16" userDrawn="1">
          <p15:clr>
            <a:srgbClr val="A4A3A4"/>
          </p15:clr>
        </p15:guide>
        <p15:guide id="2" pos="44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9"/>
    <p:restoredTop sz="94665"/>
  </p:normalViewPr>
  <p:slideViewPr>
    <p:cSldViewPr snapToGrid="0" snapToObjects="1" showGuides="1">
      <p:cViewPr varScale="1">
        <p:scale>
          <a:sx n="88" d="100"/>
          <a:sy n="88" d="100"/>
        </p:scale>
        <p:origin x="3608" y="184"/>
      </p:cViewPr>
      <p:guideLst>
        <p:guide orient="horz" pos="1916"/>
        <p:guide pos="44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8405" y="1749795"/>
            <a:ext cx="6441916" cy="3722335"/>
          </a:xfrm>
        </p:spPr>
        <p:txBody>
          <a:bodyPr anchor="b"/>
          <a:lstStyle>
            <a:lvl1pPr algn="ctr">
              <a:defRPr sz="497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7341" y="5615678"/>
            <a:ext cx="5684044" cy="2581379"/>
          </a:xfrm>
        </p:spPr>
        <p:txBody>
          <a:bodyPr/>
          <a:lstStyle>
            <a:lvl1pPr marL="0" indent="0" algn="ctr">
              <a:buNone/>
              <a:defRPr sz="1989"/>
            </a:lvl1pPr>
            <a:lvl2pPr marL="378927" indent="0" algn="ctr">
              <a:buNone/>
              <a:defRPr sz="1658"/>
            </a:lvl2pPr>
            <a:lvl3pPr marL="757855" indent="0" algn="ctr">
              <a:buNone/>
              <a:defRPr sz="1492"/>
            </a:lvl3pPr>
            <a:lvl4pPr marL="1136782" indent="0" algn="ctr">
              <a:buNone/>
              <a:defRPr sz="1326"/>
            </a:lvl4pPr>
            <a:lvl5pPr marL="1515709" indent="0" algn="ctr">
              <a:buNone/>
              <a:defRPr sz="1326"/>
            </a:lvl5pPr>
            <a:lvl6pPr marL="1894637" indent="0" algn="ctr">
              <a:buNone/>
              <a:defRPr sz="1326"/>
            </a:lvl6pPr>
            <a:lvl7pPr marL="2273564" indent="0" algn="ctr">
              <a:buNone/>
              <a:defRPr sz="1326"/>
            </a:lvl7pPr>
            <a:lvl8pPr marL="2652492" indent="0" algn="ctr">
              <a:buNone/>
              <a:defRPr sz="1326"/>
            </a:lvl8pPr>
            <a:lvl9pPr marL="3031419" indent="0" algn="ctr">
              <a:buNone/>
              <a:defRPr sz="1326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1591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2380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23525" y="569240"/>
            <a:ext cx="1634163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038" y="569240"/>
            <a:ext cx="4807754" cy="90608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6146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4244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091" y="2665532"/>
            <a:ext cx="6536650" cy="4447496"/>
          </a:xfrm>
        </p:spPr>
        <p:txBody>
          <a:bodyPr anchor="b"/>
          <a:lstStyle>
            <a:lvl1pPr>
              <a:defRPr sz="497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091" y="7155103"/>
            <a:ext cx="6536650" cy="2338833"/>
          </a:xfrm>
        </p:spPr>
        <p:txBody>
          <a:bodyPr/>
          <a:lstStyle>
            <a:lvl1pPr marL="0" indent="0">
              <a:buNone/>
              <a:defRPr sz="1989">
                <a:solidFill>
                  <a:schemeClr val="tx1"/>
                </a:solidFill>
              </a:defRPr>
            </a:lvl1pPr>
            <a:lvl2pPr marL="378927" indent="0">
              <a:buNone/>
              <a:defRPr sz="1658">
                <a:solidFill>
                  <a:schemeClr val="tx1">
                    <a:tint val="75000"/>
                  </a:schemeClr>
                </a:solidFill>
              </a:defRPr>
            </a:lvl2pPr>
            <a:lvl3pPr marL="757855" indent="0">
              <a:buNone/>
              <a:defRPr sz="1492">
                <a:solidFill>
                  <a:schemeClr val="tx1">
                    <a:tint val="75000"/>
                  </a:schemeClr>
                </a:solidFill>
              </a:defRPr>
            </a:lvl3pPr>
            <a:lvl4pPr marL="1136782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4pPr>
            <a:lvl5pPr marL="1515709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5pPr>
            <a:lvl6pPr marL="1894637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6pPr>
            <a:lvl7pPr marL="2273564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7pPr>
            <a:lvl8pPr marL="2652492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8pPr>
            <a:lvl9pPr marL="3031419" indent="0">
              <a:buNone/>
              <a:defRPr sz="132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8102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037" y="2846200"/>
            <a:ext cx="3220958" cy="6783857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6730" y="2846200"/>
            <a:ext cx="3220958" cy="6783857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4952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569242"/>
            <a:ext cx="653665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026" y="2620980"/>
            <a:ext cx="3206155" cy="1284502"/>
          </a:xfrm>
        </p:spPr>
        <p:txBody>
          <a:bodyPr anchor="b"/>
          <a:lstStyle>
            <a:lvl1pPr marL="0" indent="0">
              <a:buNone/>
              <a:defRPr sz="1989" b="1"/>
            </a:lvl1pPr>
            <a:lvl2pPr marL="378927" indent="0">
              <a:buNone/>
              <a:defRPr sz="1658" b="1"/>
            </a:lvl2pPr>
            <a:lvl3pPr marL="757855" indent="0">
              <a:buNone/>
              <a:defRPr sz="1492" b="1"/>
            </a:lvl3pPr>
            <a:lvl4pPr marL="1136782" indent="0">
              <a:buNone/>
              <a:defRPr sz="1326" b="1"/>
            </a:lvl4pPr>
            <a:lvl5pPr marL="1515709" indent="0">
              <a:buNone/>
              <a:defRPr sz="1326" b="1"/>
            </a:lvl5pPr>
            <a:lvl6pPr marL="1894637" indent="0">
              <a:buNone/>
              <a:defRPr sz="1326" b="1"/>
            </a:lvl6pPr>
            <a:lvl7pPr marL="2273564" indent="0">
              <a:buNone/>
              <a:defRPr sz="1326" b="1"/>
            </a:lvl7pPr>
            <a:lvl8pPr marL="2652492" indent="0">
              <a:buNone/>
              <a:defRPr sz="1326" b="1"/>
            </a:lvl8pPr>
            <a:lvl9pPr marL="3031419" indent="0">
              <a:buNone/>
              <a:defRPr sz="1326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026" y="3905482"/>
            <a:ext cx="3206155" cy="5744375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6730" y="2620980"/>
            <a:ext cx="3221945" cy="1284502"/>
          </a:xfrm>
        </p:spPr>
        <p:txBody>
          <a:bodyPr anchor="b"/>
          <a:lstStyle>
            <a:lvl1pPr marL="0" indent="0">
              <a:buNone/>
              <a:defRPr sz="1989" b="1"/>
            </a:lvl1pPr>
            <a:lvl2pPr marL="378927" indent="0">
              <a:buNone/>
              <a:defRPr sz="1658" b="1"/>
            </a:lvl2pPr>
            <a:lvl3pPr marL="757855" indent="0">
              <a:buNone/>
              <a:defRPr sz="1492" b="1"/>
            </a:lvl3pPr>
            <a:lvl4pPr marL="1136782" indent="0">
              <a:buNone/>
              <a:defRPr sz="1326" b="1"/>
            </a:lvl4pPr>
            <a:lvl5pPr marL="1515709" indent="0">
              <a:buNone/>
              <a:defRPr sz="1326" b="1"/>
            </a:lvl5pPr>
            <a:lvl6pPr marL="1894637" indent="0">
              <a:buNone/>
              <a:defRPr sz="1326" b="1"/>
            </a:lvl6pPr>
            <a:lvl7pPr marL="2273564" indent="0">
              <a:buNone/>
              <a:defRPr sz="1326" b="1"/>
            </a:lvl7pPr>
            <a:lvl8pPr marL="2652492" indent="0">
              <a:buNone/>
              <a:defRPr sz="1326" b="1"/>
            </a:lvl8pPr>
            <a:lvl9pPr marL="3031419" indent="0">
              <a:buNone/>
              <a:defRPr sz="1326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6730" y="3905482"/>
            <a:ext cx="3221945" cy="5744375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3275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8299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9019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712788"/>
            <a:ext cx="2444336" cy="2494756"/>
          </a:xfrm>
        </p:spPr>
        <p:txBody>
          <a:bodyPr anchor="b"/>
          <a:lstStyle>
            <a:lvl1pPr>
              <a:defRPr sz="265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1945" y="1539425"/>
            <a:ext cx="3836730" cy="7598117"/>
          </a:xfrm>
        </p:spPr>
        <p:txBody>
          <a:bodyPr/>
          <a:lstStyle>
            <a:lvl1pPr>
              <a:defRPr sz="2652"/>
            </a:lvl1pPr>
            <a:lvl2pPr>
              <a:defRPr sz="2321"/>
            </a:lvl2pPr>
            <a:lvl3pPr>
              <a:defRPr sz="1989"/>
            </a:lvl3pPr>
            <a:lvl4pPr>
              <a:defRPr sz="1658"/>
            </a:lvl4pPr>
            <a:lvl5pPr>
              <a:defRPr sz="1658"/>
            </a:lvl5pPr>
            <a:lvl6pPr>
              <a:defRPr sz="1658"/>
            </a:lvl6pPr>
            <a:lvl7pPr>
              <a:defRPr sz="1658"/>
            </a:lvl7pPr>
            <a:lvl8pPr>
              <a:defRPr sz="1658"/>
            </a:lvl8pPr>
            <a:lvl9pPr>
              <a:defRPr sz="1658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025" y="3207544"/>
            <a:ext cx="2444336" cy="5942372"/>
          </a:xfrm>
        </p:spPr>
        <p:txBody>
          <a:bodyPr/>
          <a:lstStyle>
            <a:lvl1pPr marL="0" indent="0">
              <a:buNone/>
              <a:defRPr sz="1326"/>
            </a:lvl1pPr>
            <a:lvl2pPr marL="378927" indent="0">
              <a:buNone/>
              <a:defRPr sz="1160"/>
            </a:lvl2pPr>
            <a:lvl3pPr marL="757855" indent="0">
              <a:buNone/>
              <a:defRPr sz="995"/>
            </a:lvl3pPr>
            <a:lvl4pPr marL="1136782" indent="0">
              <a:buNone/>
              <a:defRPr sz="829"/>
            </a:lvl4pPr>
            <a:lvl5pPr marL="1515709" indent="0">
              <a:buNone/>
              <a:defRPr sz="829"/>
            </a:lvl5pPr>
            <a:lvl6pPr marL="1894637" indent="0">
              <a:buNone/>
              <a:defRPr sz="829"/>
            </a:lvl6pPr>
            <a:lvl7pPr marL="2273564" indent="0">
              <a:buNone/>
              <a:defRPr sz="829"/>
            </a:lvl7pPr>
            <a:lvl8pPr marL="2652492" indent="0">
              <a:buNone/>
              <a:defRPr sz="829"/>
            </a:lvl8pPr>
            <a:lvl9pPr marL="3031419" indent="0">
              <a:buNone/>
              <a:defRPr sz="829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2508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025" y="712788"/>
            <a:ext cx="2444336" cy="2494756"/>
          </a:xfrm>
        </p:spPr>
        <p:txBody>
          <a:bodyPr anchor="b"/>
          <a:lstStyle>
            <a:lvl1pPr>
              <a:defRPr sz="265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1945" y="1539425"/>
            <a:ext cx="3836730" cy="7598117"/>
          </a:xfrm>
        </p:spPr>
        <p:txBody>
          <a:bodyPr anchor="t"/>
          <a:lstStyle>
            <a:lvl1pPr marL="0" indent="0">
              <a:buNone/>
              <a:defRPr sz="2652"/>
            </a:lvl1pPr>
            <a:lvl2pPr marL="378927" indent="0">
              <a:buNone/>
              <a:defRPr sz="2321"/>
            </a:lvl2pPr>
            <a:lvl3pPr marL="757855" indent="0">
              <a:buNone/>
              <a:defRPr sz="1989"/>
            </a:lvl3pPr>
            <a:lvl4pPr marL="1136782" indent="0">
              <a:buNone/>
              <a:defRPr sz="1658"/>
            </a:lvl4pPr>
            <a:lvl5pPr marL="1515709" indent="0">
              <a:buNone/>
              <a:defRPr sz="1658"/>
            </a:lvl5pPr>
            <a:lvl6pPr marL="1894637" indent="0">
              <a:buNone/>
              <a:defRPr sz="1658"/>
            </a:lvl6pPr>
            <a:lvl7pPr marL="2273564" indent="0">
              <a:buNone/>
              <a:defRPr sz="1658"/>
            </a:lvl7pPr>
            <a:lvl8pPr marL="2652492" indent="0">
              <a:buNone/>
              <a:defRPr sz="1658"/>
            </a:lvl8pPr>
            <a:lvl9pPr marL="3031419" indent="0">
              <a:buNone/>
              <a:defRPr sz="1658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025" y="3207544"/>
            <a:ext cx="2444336" cy="5942372"/>
          </a:xfrm>
        </p:spPr>
        <p:txBody>
          <a:bodyPr/>
          <a:lstStyle>
            <a:lvl1pPr marL="0" indent="0">
              <a:buNone/>
              <a:defRPr sz="1326"/>
            </a:lvl1pPr>
            <a:lvl2pPr marL="378927" indent="0">
              <a:buNone/>
              <a:defRPr sz="1160"/>
            </a:lvl2pPr>
            <a:lvl3pPr marL="757855" indent="0">
              <a:buNone/>
              <a:defRPr sz="995"/>
            </a:lvl3pPr>
            <a:lvl4pPr marL="1136782" indent="0">
              <a:buNone/>
              <a:defRPr sz="829"/>
            </a:lvl4pPr>
            <a:lvl5pPr marL="1515709" indent="0">
              <a:buNone/>
              <a:defRPr sz="829"/>
            </a:lvl5pPr>
            <a:lvl6pPr marL="1894637" indent="0">
              <a:buNone/>
              <a:defRPr sz="829"/>
            </a:lvl6pPr>
            <a:lvl7pPr marL="2273564" indent="0">
              <a:buNone/>
              <a:defRPr sz="829"/>
            </a:lvl7pPr>
            <a:lvl8pPr marL="2652492" indent="0">
              <a:buNone/>
              <a:defRPr sz="829"/>
            </a:lvl8pPr>
            <a:lvl9pPr marL="3031419" indent="0">
              <a:buNone/>
              <a:defRPr sz="829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7734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038" y="569242"/>
            <a:ext cx="653665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038" y="2846200"/>
            <a:ext cx="653665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037" y="9909729"/>
            <a:ext cx="1705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D2F91-5250-EC43-8C43-CBE462FC5582}" type="datetimeFigureOut">
              <a:rPr lang="fr-FR" smtClean="0"/>
              <a:t>27/01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0453" y="9909729"/>
            <a:ext cx="255782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52475" y="9909729"/>
            <a:ext cx="1705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C6CBB6-08EB-2B44-8013-EBDCA13E047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7750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7855" rtl="0" eaLnBrk="1" latinLnBrk="0" hangingPunct="1">
        <a:lnSpc>
          <a:spcPct val="90000"/>
        </a:lnSpc>
        <a:spcBef>
          <a:spcPct val="0"/>
        </a:spcBef>
        <a:buNone/>
        <a:defRPr sz="36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464" indent="-189464" algn="l" defTabSz="757855" rtl="0" eaLnBrk="1" latinLnBrk="0" hangingPunct="1">
        <a:lnSpc>
          <a:spcPct val="90000"/>
        </a:lnSpc>
        <a:spcBef>
          <a:spcPts val="829"/>
        </a:spcBef>
        <a:buFont typeface="Arial" panose="020B0604020202020204" pitchFamily="34" charset="0"/>
        <a:buChar char="•"/>
        <a:defRPr sz="2321" kern="1200">
          <a:solidFill>
            <a:schemeClr val="tx1"/>
          </a:solidFill>
          <a:latin typeface="+mn-lt"/>
          <a:ea typeface="+mn-ea"/>
          <a:cs typeface="+mn-cs"/>
        </a:defRPr>
      </a:lvl1pPr>
      <a:lvl2pPr marL="568391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989" kern="1200">
          <a:solidFill>
            <a:schemeClr val="tx1"/>
          </a:solidFill>
          <a:latin typeface="+mn-lt"/>
          <a:ea typeface="+mn-ea"/>
          <a:cs typeface="+mn-cs"/>
        </a:defRPr>
      </a:lvl2pPr>
      <a:lvl3pPr marL="947318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658" kern="1200">
          <a:solidFill>
            <a:schemeClr val="tx1"/>
          </a:solidFill>
          <a:latin typeface="+mn-lt"/>
          <a:ea typeface="+mn-ea"/>
          <a:cs typeface="+mn-cs"/>
        </a:defRPr>
      </a:lvl3pPr>
      <a:lvl4pPr marL="1326246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4pPr>
      <a:lvl5pPr marL="1705173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5pPr>
      <a:lvl6pPr marL="2084100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6pPr>
      <a:lvl7pPr marL="2463028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7pPr>
      <a:lvl8pPr marL="2841955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8pPr>
      <a:lvl9pPr marL="3220883" indent="-189464" algn="l" defTabSz="757855" rtl="0" eaLnBrk="1" latinLnBrk="0" hangingPunct="1">
        <a:lnSpc>
          <a:spcPct val="90000"/>
        </a:lnSpc>
        <a:spcBef>
          <a:spcPts val="414"/>
        </a:spcBef>
        <a:buFont typeface="Arial" panose="020B0604020202020204" pitchFamily="34" charset="0"/>
        <a:buChar char="•"/>
        <a:defRPr sz="149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1pPr>
      <a:lvl2pPr marL="378927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2pPr>
      <a:lvl3pPr marL="757855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3pPr>
      <a:lvl4pPr marL="1136782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4pPr>
      <a:lvl5pPr marL="1515709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5pPr>
      <a:lvl6pPr marL="1894637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6pPr>
      <a:lvl7pPr marL="2273564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7pPr>
      <a:lvl8pPr marL="2652492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8pPr>
      <a:lvl9pPr marL="3031419" algn="l" defTabSz="757855" rtl="0" eaLnBrk="1" latinLnBrk="0" hangingPunct="1">
        <a:defRPr sz="149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e 17">
            <a:extLst>
              <a:ext uri="{FF2B5EF4-FFF2-40B4-BE49-F238E27FC236}">
                <a16:creationId xmlns:a16="http://schemas.microsoft.com/office/drawing/2014/main" id="{321597C6-12D6-7245-87C3-7206C784D692}"/>
              </a:ext>
            </a:extLst>
          </p:cNvPr>
          <p:cNvGrpSpPr>
            <a:grpSpLocks noChangeAspect="1"/>
          </p:cNvGrpSpPr>
          <p:nvPr/>
        </p:nvGrpSpPr>
        <p:grpSpPr>
          <a:xfrm>
            <a:off x="290030" y="1295951"/>
            <a:ext cx="6840000" cy="4083622"/>
            <a:chOff x="829500" y="235778"/>
            <a:chExt cx="10304666" cy="6152098"/>
          </a:xfrm>
        </p:grpSpPr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31F7682C-22C4-4549-B0F1-3BB9F91AFA7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3778" y="3517676"/>
              <a:ext cx="2679700" cy="2870200"/>
            </a:xfrm>
            <a:prstGeom prst="rect">
              <a:avLst/>
            </a:prstGeom>
          </p:spPr>
        </p:pic>
        <p:pic>
          <p:nvPicPr>
            <p:cNvPr id="20" name="Image 19">
              <a:extLst>
                <a:ext uri="{FF2B5EF4-FFF2-40B4-BE49-F238E27FC236}">
                  <a16:creationId xmlns:a16="http://schemas.microsoft.com/office/drawing/2014/main" id="{D4AE396C-0B15-304A-A69D-8CBB496E1DB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64131" y="3441038"/>
              <a:ext cx="2679700" cy="2921000"/>
            </a:xfrm>
            <a:prstGeom prst="rect">
              <a:avLst/>
            </a:prstGeom>
          </p:spPr>
        </p:pic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1017FEA0-0FA1-A341-AA66-A73C2CA40FC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9500" y="290768"/>
              <a:ext cx="3689789" cy="3168000"/>
            </a:xfrm>
            <a:prstGeom prst="rect">
              <a:avLst/>
            </a:prstGeom>
          </p:spPr>
        </p:pic>
        <p:pic>
          <p:nvPicPr>
            <p:cNvPr id="22" name="Image 21">
              <a:extLst>
                <a:ext uri="{FF2B5EF4-FFF2-40B4-BE49-F238E27FC236}">
                  <a16:creationId xmlns:a16="http://schemas.microsoft.com/office/drawing/2014/main" id="{3401DFA9-C752-6F46-9C1A-94017215FCD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76264" y="3652555"/>
              <a:ext cx="2667000" cy="2730500"/>
            </a:xfrm>
            <a:prstGeom prst="rect">
              <a:avLst/>
            </a:prstGeom>
          </p:spPr>
        </p:pic>
        <p:pic>
          <p:nvPicPr>
            <p:cNvPr id="23" name="Image 22">
              <a:extLst>
                <a:ext uri="{FF2B5EF4-FFF2-40B4-BE49-F238E27FC236}">
                  <a16:creationId xmlns:a16="http://schemas.microsoft.com/office/drawing/2014/main" id="{EA4B8092-FE86-CF4C-9DDB-FD30ACF430F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359910" y="278732"/>
              <a:ext cx="3491265" cy="3168000"/>
            </a:xfrm>
            <a:prstGeom prst="rect">
              <a:avLst/>
            </a:prstGeom>
          </p:spPr>
        </p:pic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2E21A589-6768-0846-B190-D1A0A58B4162}"/>
                </a:ext>
              </a:extLst>
            </p:cNvPr>
            <p:cNvSpPr txBox="1"/>
            <p:nvPr/>
          </p:nvSpPr>
          <p:spPr>
            <a:xfrm>
              <a:off x="4368580" y="34876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42290459-0331-C544-AA84-81596A732863}"/>
                </a:ext>
              </a:extLst>
            </p:cNvPr>
            <p:cNvSpPr txBox="1"/>
            <p:nvPr/>
          </p:nvSpPr>
          <p:spPr>
            <a:xfrm flipH="1">
              <a:off x="891107" y="329013"/>
              <a:ext cx="1796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979053E2-6BAC-C140-90B6-39D68342F06C}"/>
                </a:ext>
              </a:extLst>
            </p:cNvPr>
            <p:cNvSpPr txBox="1"/>
            <p:nvPr/>
          </p:nvSpPr>
          <p:spPr>
            <a:xfrm>
              <a:off x="4247086" y="3318745"/>
              <a:ext cx="2692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1416929D-F4C4-F44E-B88B-AF52A73F587C}"/>
                </a:ext>
              </a:extLst>
            </p:cNvPr>
            <p:cNvSpPr txBox="1"/>
            <p:nvPr/>
          </p:nvSpPr>
          <p:spPr>
            <a:xfrm>
              <a:off x="890337" y="3296654"/>
              <a:ext cx="3889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28" name="Image 27">
              <a:extLst>
                <a:ext uri="{FF2B5EF4-FFF2-40B4-BE49-F238E27FC236}">
                  <a16:creationId xmlns:a16="http://schemas.microsoft.com/office/drawing/2014/main" id="{03BAA6A0-E292-F846-9579-0FB2BDED271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705166" y="235778"/>
              <a:ext cx="3429000" cy="3187700"/>
            </a:xfrm>
            <a:prstGeom prst="rect">
              <a:avLst/>
            </a:prstGeom>
          </p:spPr>
        </p:pic>
      </p:grpSp>
      <p:sp>
        <p:nvSpPr>
          <p:cNvPr id="3" name="Rectangle 2">
            <a:extLst>
              <a:ext uri="{FF2B5EF4-FFF2-40B4-BE49-F238E27FC236}">
                <a16:creationId xmlns:a16="http://schemas.microsoft.com/office/drawing/2014/main" id="{7172C3FD-5893-BD48-B9F8-BE0F7EE809CF}"/>
              </a:ext>
            </a:extLst>
          </p:cNvPr>
          <p:cNvSpPr/>
          <p:nvPr/>
        </p:nvSpPr>
        <p:spPr>
          <a:xfrm>
            <a:off x="654639" y="5469078"/>
            <a:ext cx="6275012" cy="32316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4288" algn="just">
              <a:spcAft>
                <a:spcPts val="0"/>
              </a:spcAft>
            </a:pPr>
            <a:r>
              <a:rPr lang="en-GB" sz="1200" b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l Figure 1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Counts and Proportions of 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lood and spleen CD4</a:t>
            </a:r>
            <a:r>
              <a:rPr lang="en-US" sz="1200" b="1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T-cells and activated T-cells.  (A)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bsolute numbers of CD4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-cells in PBMC and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Percentages of blood CD4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CD8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-cells expressing Ki67 were plotted for each macaque before infection (D0) at 10dpi (D10) and 28dpi (D28). Each dot represents one macaque of Placebo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pen circle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or Treated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lack circle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group. Bars represent Mean values ± SEM. Statistics were first carried out to compare values at different time point for each macaque using the one-way ANOVA with Bonferroni’s multiple comparisons test. Significant statistical values are indicted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lain line, *p&lt;0.05, ** p&lt;0.01, ***p&lt;0.001, ****p&lt;0.0001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. Difference between absolute numbers at D28 and D0 was also compared between groups using the Mann Whitney non-parametric test.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tatistical values are indicated for each panel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otted line and p value, ns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not significant). Percentages of spleen CD4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T-cells in CD3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-cells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and of spleen CD4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and CD8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+ 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T-cells expressing Ki67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D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were determined in non-infected macaques (SIV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Placebo and BR3-Fc treated SIV-infected macaques at 28dpi. (</a:t>
            </a:r>
            <a:r>
              <a:rPr lang="en-GB" sz="12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-D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Each dot represents one macaque from SIV</a:t>
            </a:r>
            <a:r>
              <a:rPr lang="en-GB" sz="1200" baseline="30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lack triangle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, Placebo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pen circle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 or Treated group (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black circle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. Bars represent Mean values ±SEM. Statistics were first carried out to compare values at different time point for each macaque using one-way ANOVA with Bonferroni’s multiple comparisons test. Significant statistical values are indicted </a:t>
            </a:r>
            <a:r>
              <a:rPr lang="en-GB" sz="12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*p&lt;0.05, ** p&lt;0.01, ****p&lt;0.0001</a:t>
            </a:r>
            <a:r>
              <a:rPr lang="en-GB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</a:t>
            </a:r>
            <a:endParaRPr lang="fr-FR" sz="1200" dirty="0">
              <a:effectLst/>
              <a:latin typeface="Cambria" panose="02040503050406030204" pitchFamily="18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32174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308</Words>
  <Application>Microsoft Macintosh PowerPoint</Application>
  <PresentationFormat>Personnalisé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Cambria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RICHARD</dc:creator>
  <cp:lastModifiedBy>Yolande RICHARD</cp:lastModifiedBy>
  <cp:revision>4</cp:revision>
  <dcterms:created xsi:type="dcterms:W3CDTF">2020-01-22T17:12:16Z</dcterms:created>
  <dcterms:modified xsi:type="dcterms:W3CDTF">2020-01-27T09:55:46Z</dcterms:modified>
</cp:coreProperties>
</file>